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80" d="100"/>
          <a:sy n="80" d="100"/>
        </p:scale>
        <p:origin x="61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577985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530495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410338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770993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728295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716544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204680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725514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95715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492838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545525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784211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>
            <a:extLst>
              <a:ext uri="{FF2B5EF4-FFF2-40B4-BE49-F238E27FC236}">
                <a16:creationId xmlns:a16="http://schemas.microsoft.com/office/drawing/2014/main" id="{0CECCE0D-130B-4D79-97F8-BC119032B6FA}"/>
              </a:ext>
            </a:extLst>
          </p:cNvPr>
          <p:cNvSpPr txBox="1"/>
          <p:nvPr/>
        </p:nvSpPr>
        <p:spPr>
          <a:xfrm>
            <a:off x="273974" y="507419"/>
            <a:ext cx="6033838" cy="9766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Unprocessed S3 Fig.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ignal detection was performed as described in the Material and methods section of the accompanying manuscript. Red rectangles indicate the cropped images shown in the respective manuscript figures. </a:t>
            </a:r>
            <a:endParaRPr lang="fr-FR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8" name="Picture 3" descr="A picture containing text, screenshot, line&#10;&#10;Description automatically generated">
            <a:extLst>
              <a:ext uri="{FF2B5EF4-FFF2-40B4-BE49-F238E27FC236}">
                <a16:creationId xmlns:a16="http://schemas.microsoft.com/office/drawing/2014/main" id="{3FE26E11-F21F-41CF-8174-A314B3981FF8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1832" y="1700062"/>
            <a:ext cx="5935980" cy="653796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25303271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34</Words>
  <Application>Microsoft Office PowerPoint</Application>
  <PresentationFormat>Affichage à l'écran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allois Jean-Luc</dc:creator>
  <cp:lastModifiedBy>Gallois Jean-Luc</cp:lastModifiedBy>
  <cp:revision>3</cp:revision>
  <dcterms:created xsi:type="dcterms:W3CDTF">2023-09-11T13:58:36Z</dcterms:created>
  <dcterms:modified xsi:type="dcterms:W3CDTF">2023-09-11T14:03:07Z</dcterms:modified>
</cp:coreProperties>
</file>